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C1136FF-8F9B-4382-A171-B090A6738493}" v="1" dt="2024-06-10T16:58:07.9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43" autoAdjust="0"/>
    <p:restoredTop sz="94660"/>
  </p:normalViewPr>
  <p:slideViewPr>
    <p:cSldViewPr snapToGrid="0">
      <p:cViewPr>
        <p:scale>
          <a:sx n="170" d="100"/>
          <a:sy n="170" d="100"/>
        </p:scale>
        <p:origin x="451" y="-46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vier Sierra Isturiz" userId="d8b3d0ae-a242-4736-98fc-9ee2342b4e28" providerId="ADAL" clId="{8C1136FF-8F9B-4382-A171-B090A6738493}"/>
    <pc:docChg chg="modSld">
      <pc:chgData name="Javier Sierra Isturiz" userId="d8b3d0ae-a242-4736-98fc-9ee2342b4e28" providerId="ADAL" clId="{8C1136FF-8F9B-4382-A171-B090A6738493}" dt="2024-06-10T16:58:07.967" v="0" actId="164"/>
      <pc:docMkLst>
        <pc:docMk/>
      </pc:docMkLst>
      <pc:sldChg chg="addSp modSp">
        <pc:chgData name="Javier Sierra Isturiz" userId="d8b3d0ae-a242-4736-98fc-9ee2342b4e28" providerId="ADAL" clId="{8C1136FF-8F9B-4382-A171-B090A6738493}" dt="2024-06-10T16:58:07.967" v="0" actId="164"/>
        <pc:sldMkLst>
          <pc:docMk/>
          <pc:sldMk cId="1569249073" sldId="256"/>
        </pc:sldMkLst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3" creationId="{E9596936-1498-D3F6-AA8C-914088CD5002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4" creationId="{020124B9-73FB-D525-2DFB-DD402F9080A4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6" creationId="{A1EB9BEB-8151-63CD-8F00-6C7FFB262666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10" creationId="{648D1C93-CD5A-0A2F-A735-1E43487D1BC8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14" creationId="{2BB6BB56-847C-291D-1F05-D2AC8532FD33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23" creationId="{D627B80C-2BB3-6CBA-15A1-46D72FCDE3E4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24" creationId="{67CB3336-1384-C3E5-E182-48ACF413A7F0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25" creationId="{B8170366-D130-2FF5-25CC-4A249FF1FF14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26" creationId="{01E7BE88-FEC3-D353-CEDF-58E12513573B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29" creationId="{77783D53-1C64-6AAF-244A-312D5C5A901D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30" creationId="{BADD43E2-80A0-27CF-1D67-9C20DC4C06C0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32" creationId="{555E9F5D-A13C-3560-DE45-4E10B3ED8140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36" creationId="{9E14A5BF-EB9E-21CF-21A8-7E35C7B7583B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42" creationId="{738D7E52-B912-28C8-780B-EFC3255084E0}"/>
          </ac:spMkLst>
        </pc:spChg>
        <pc:spChg chg="mod">
          <ac:chgData name="Javier Sierra Isturiz" userId="d8b3d0ae-a242-4736-98fc-9ee2342b4e28" providerId="ADAL" clId="{8C1136FF-8F9B-4382-A171-B090A6738493}" dt="2024-06-10T16:58:07.967" v="0" actId="164"/>
          <ac:spMkLst>
            <pc:docMk/>
            <pc:sldMk cId="1569249073" sldId="256"/>
            <ac:spMk id="44" creationId="{A3A56923-E4B1-C7CE-31A9-9ADB4EFCB182}"/>
          </ac:spMkLst>
        </pc:spChg>
        <pc:grpChg chg="add mod">
          <ac:chgData name="Javier Sierra Isturiz" userId="d8b3d0ae-a242-4736-98fc-9ee2342b4e28" providerId="ADAL" clId="{8C1136FF-8F9B-4382-A171-B090A6738493}" dt="2024-06-10T16:58:07.967" v="0" actId="164"/>
          <ac:grpSpMkLst>
            <pc:docMk/>
            <pc:sldMk cId="1569249073" sldId="256"/>
            <ac:grpSpMk id="2" creationId="{2E38568C-73EA-C7D5-C50D-01F5CB019612}"/>
          </ac:grpSpMkLst>
        </pc:grpChg>
        <pc:picChg chg="mod">
          <ac:chgData name="Javier Sierra Isturiz" userId="d8b3d0ae-a242-4736-98fc-9ee2342b4e28" providerId="ADAL" clId="{8C1136FF-8F9B-4382-A171-B090A6738493}" dt="2024-06-10T16:58:07.967" v="0" actId="164"/>
          <ac:picMkLst>
            <pc:docMk/>
            <pc:sldMk cId="1569249073" sldId="256"/>
            <ac:picMk id="8" creationId="{860FFE88-7613-579A-CC24-60A699DEE8F1}"/>
          </ac:picMkLst>
        </pc:picChg>
        <pc:picChg chg="mod">
          <ac:chgData name="Javier Sierra Isturiz" userId="d8b3d0ae-a242-4736-98fc-9ee2342b4e28" providerId="ADAL" clId="{8C1136FF-8F9B-4382-A171-B090A6738493}" dt="2024-06-10T16:58:07.967" v="0" actId="164"/>
          <ac:picMkLst>
            <pc:docMk/>
            <pc:sldMk cId="1569249073" sldId="256"/>
            <ac:picMk id="13" creationId="{B1EBA450-E46E-E414-2734-6E14D25E3A0C}"/>
          </ac:picMkLst>
        </pc:picChg>
        <pc:picChg chg="mod">
          <ac:chgData name="Javier Sierra Isturiz" userId="d8b3d0ae-a242-4736-98fc-9ee2342b4e28" providerId="ADAL" clId="{8C1136FF-8F9B-4382-A171-B090A6738493}" dt="2024-06-10T16:58:07.967" v="0" actId="164"/>
          <ac:picMkLst>
            <pc:docMk/>
            <pc:sldMk cId="1569249073" sldId="256"/>
            <ac:picMk id="15" creationId="{50048012-E549-9E92-61F0-251DD9B8C263}"/>
          </ac:picMkLst>
        </pc:picChg>
        <pc:picChg chg="mod">
          <ac:chgData name="Javier Sierra Isturiz" userId="d8b3d0ae-a242-4736-98fc-9ee2342b4e28" providerId="ADAL" clId="{8C1136FF-8F9B-4382-A171-B090A6738493}" dt="2024-06-10T16:58:07.967" v="0" actId="164"/>
          <ac:picMkLst>
            <pc:docMk/>
            <pc:sldMk cId="1569249073" sldId="256"/>
            <ac:picMk id="19" creationId="{6685A1F9-A41D-E499-8A76-BAFB9B5CBD43}"/>
          </ac:picMkLst>
        </pc:picChg>
        <pc:picChg chg="mod">
          <ac:chgData name="Javier Sierra Isturiz" userId="d8b3d0ae-a242-4736-98fc-9ee2342b4e28" providerId="ADAL" clId="{8C1136FF-8F9B-4382-A171-B090A6738493}" dt="2024-06-10T16:58:07.967" v="0" actId="164"/>
          <ac:picMkLst>
            <pc:docMk/>
            <pc:sldMk cId="1569249073" sldId="256"/>
            <ac:picMk id="34" creationId="{1FE2919B-E6B7-5B38-0171-FE45EF94DA5C}"/>
          </ac:picMkLst>
        </pc:picChg>
        <pc:picChg chg="mod">
          <ac:chgData name="Javier Sierra Isturiz" userId="d8b3d0ae-a242-4736-98fc-9ee2342b4e28" providerId="ADAL" clId="{8C1136FF-8F9B-4382-A171-B090A6738493}" dt="2024-06-10T16:58:07.967" v="0" actId="164"/>
          <ac:picMkLst>
            <pc:docMk/>
            <pc:sldMk cId="1569249073" sldId="256"/>
            <ac:picMk id="35" creationId="{A17D1C5C-56D6-C8B6-43AB-62D5BAE6B04F}"/>
          </ac:picMkLst>
        </pc:picChg>
        <pc:picChg chg="mod">
          <ac:chgData name="Javier Sierra Isturiz" userId="d8b3d0ae-a242-4736-98fc-9ee2342b4e28" providerId="ADAL" clId="{8C1136FF-8F9B-4382-A171-B090A6738493}" dt="2024-06-10T16:58:07.967" v="0" actId="164"/>
          <ac:picMkLst>
            <pc:docMk/>
            <pc:sldMk cId="1569249073" sldId="256"/>
            <ac:picMk id="41" creationId="{C90FD3E4-4850-1F47-5849-60364615F1A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9013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2550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8678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5354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5353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8388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4075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9062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7436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934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8984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C34C1B-0E3B-4F2B-A2C3-EBD44B9A275F}" type="datetimeFigureOut">
              <a:rPr lang="es-ES" smtClean="0"/>
              <a:t>10/06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25CAA-7645-4450-B9E3-00589696DFC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8237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jpg"/><Relationship Id="rId7" Type="http://schemas.microsoft.com/office/2007/relationships/hdphoto" Target="../media/hdphoto2.wdp"/><Relationship Id="rId12" Type="http://schemas.openxmlformats.org/officeDocument/2006/relationships/image" Target="../media/image7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3.wdp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2E38568C-73EA-C7D5-C50D-01F5CB019612}"/>
              </a:ext>
            </a:extLst>
          </p:cNvPr>
          <p:cNvGrpSpPr/>
          <p:nvPr/>
        </p:nvGrpSpPr>
        <p:grpSpPr>
          <a:xfrm>
            <a:off x="578121" y="231170"/>
            <a:ext cx="5852494" cy="11960830"/>
            <a:chOff x="578121" y="231170"/>
            <a:chExt cx="5852494" cy="11960830"/>
          </a:xfrm>
        </p:grpSpPr>
        <p:pic>
          <p:nvPicPr>
            <p:cNvPr id="19" name="Imagen 18" descr="Imagen que contiene interior, computadora, teclado, estrella&#10;&#10;Descripción generada automáticamente">
              <a:extLst>
                <a:ext uri="{FF2B5EF4-FFF2-40B4-BE49-F238E27FC236}">
                  <a16:creationId xmlns:a16="http://schemas.microsoft.com/office/drawing/2014/main" id="{6685A1F9-A41D-E499-8A76-BAFB9B5CBD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0615" y="6491696"/>
              <a:ext cx="2880000" cy="2880000"/>
            </a:xfrm>
            <a:prstGeom prst="rect">
              <a:avLst/>
            </a:prstGeom>
          </p:spPr>
        </p:pic>
        <p:pic>
          <p:nvPicPr>
            <p:cNvPr id="34" name="Imagen 33" descr="Una estrella de color morado&#10;&#10;Descripción generada automáticamente con confianza media">
              <a:extLst>
                <a:ext uri="{FF2B5EF4-FFF2-40B4-BE49-F238E27FC236}">
                  <a16:creationId xmlns:a16="http://schemas.microsoft.com/office/drawing/2014/main" id="{1FE2919B-E6B7-5B38-0171-FE45EF94DA5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3718" y="3549092"/>
              <a:ext cx="2880000" cy="2880000"/>
            </a:xfrm>
            <a:prstGeom prst="rect">
              <a:avLst/>
            </a:prstGeom>
          </p:spPr>
        </p:pic>
        <p:pic>
          <p:nvPicPr>
            <p:cNvPr id="13" name="Imagen 12" descr="Imagen que contiene pasto, verde, campo, tabla&#10;&#10;Descripción generada automáticamente">
              <a:extLst>
                <a:ext uri="{FF2B5EF4-FFF2-40B4-BE49-F238E27FC236}">
                  <a16:creationId xmlns:a16="http://schemas.microsoft.com/office/drawing/2014/main" id="{B1EBA450-E46E-E414-2734-6E14D25E3A0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8121" y="592814"/>
              <a:ext cx="2880000" cy="2880000"/>
            </a:xfrm>
            <a:prstGeom prst="rect">
              <a:avLst/>
            </a:prstGeom>
          </p:spPr>
        </p:pic>
        <p:sp>
          <p:nvSpPr>
            <p:cNvPr id="29" name="Text Box 4">
              <a:extLst>
                <a:ext uri="{FF2B5EF4-FFF2-40B4-BE49-F238E27FC236}">
                  <a16:creationId xmlns:a16="http://schemas.microsoft.com/office/drawing/2014/main" id="{77783D53-1C64-6AAF-244A-312D5C5A90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51446" y="231170"/>
              <a:ext cx="1824727" cy="278507"/>
            </a:xfrm>
            <a:prstGeom prst="rect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  <a:defRPr/>
              </a:pPr>
              <a:r>
                <a:rPr lang="es-ES" sz="1600" b="1" dirty="0" err="1">
                  <a:solidFill>
                    <a:prstClr val="black"/>
                  </a:solidFill>
                  <a:latin typeface="Calibri" pitchFamily="34" charset="0"/>
                  <a:cs typeface="Arial" pitchFamily="34" charset="0"/>
                </a:rPr>
                <a:t>Neurons</a:t>
              </a:r>
              <a:endParaRPr kumimoji="0" lang="es-ES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endParaRPr>
            </a:p>
          </p:txBody>
        </p:sp>
        <p:sp>
          <p:nvSpPr>
            <p:cNvPr id="30" name="Text Box 4">
              <a:extLst>
                <a:ext uri="{FF2B5EF4-FFF2-40B4-BE49-F238E27FC236}">
                  <a16:creationId xmlns:a16="http://schemas.microsoft.com/office/drawing/2014/main" id="{BADD43E2-80A0-27CF-1D67-9C20DC4C06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074036" y="239794"/>
              <a:ext cx="1824727" cy="278507"/>
            </a:xfrm>
            <a:prstGeom prst="rect">
              <a:avLst/>
            </a:prstGeom>
            <a:solidFill>
              <a:srgbClr val="FFFFFF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ts val="10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16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itchFamily="34" charset="0"/>
                  <a:ea typeface="+mn-ea"/>
                  <a:cs typeface="Arial" pitchFamily="34" charset="0"/>
                </a:rPr>
                <a:t>hmOEG</a:t>
              </a:r>
              <a:endParaRPr kumimoji="0" lang="es-ES" sz="2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itchFamily="34" charset="0"/>
                <a:ea typeface="+mn-ea"/>
                <a:cs typeface="Arial" pitchFamily="34" charset="0"/>
              </a:endParaRPr>
            </a:p>
          </p:txBody>
        </p: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E9596936-1498-D3F6-AA8C-914088CD5002}"/>
                </a:ext>
              </a:extLst>
            </p:cNvPr>
            <p:cNvSpPr txBox="1"/>
            <p:nvPr/>
          </p:nvSpPr>
          <p:spPr>
            <a:xfrm>
              <a:off x="578121" y="3124106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j1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pic>
          <p:nvPicPr>
            <p:cNvPr id="15" name="Imagen 14">
              <a:extLst>
                <a:ext uri="{FF2B5EF4-FFF2-40B4-BE49-F238E27FC236}">
                  <a16:creationId xmlns:a16="http://schemas.microsoft.com/office/drawing/2014/main" id="{50048012-E549-9E92-61F0-251DD9B8C26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6400" y="588653"/>
              <a:ext cx="2880000" cy="2880000"/>
            </a:xfrm>
            <a:prstGeom prst="rect">
              <a:avLst/>
            </a:prstGeom>
          </p:spPr>
        </p:pic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B8170366-D130-2FF5-25CC-4A249FF1FF14}"/>
                </a:ext>
              </a:extLst>
            </p:cNvPr>
            <p:cNvSpPr txBox="1"/>
            <p:nvPr/>
          </p:nvSpPr>
          <p:spPr>
            <a:xfrm>
              <a:off x="3548776" y="3134260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j1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555E9F5D-A13C-3560-DE45-4E10B3ED8140}"/>
                </a:ext>
              </a:extLst>
            </p:cNvPr>
            <p:cNvSpPr txBox="1"/>
            <p:nvPr/>
          </p:nvSpPr>
          <p:spPr>
            <a:xfrm>
              <a:off x="579279" y="6077566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N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Imagen 34" descr="Imagen que contiene interior, teclado, computadora, computer&#10;&#10;Descripción generada automáticamente">
              <a:extLst>
                <a:ext uri="{FF2B5EF4-FFF2-40B4-BE49-F238E27FC236}">
                  <a16:creationId xmlns:a16="http://schemas.microsoft.com/office/drawing/2014/main" id="{A17D1C5C-56D6-C8B6-43AB-62D5BAE6B04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43754" y="3550124"/>
              <a:ext cx="2880000" cy="2880000"/>
            </a:xfrm>
            <a:prstGeom prst="rect">
              <a:avLst/>
            </a:prstGeom>
          </p:spPr>
        </p:pic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9E14A5BF-EB9E-21CF-21A8-7E35C7B7583B}"/>
                </a:ext>
              </a:extLst>
            </p:cNvPr>
            <p:cNvSpPr txBox="1"/>
            <p:nvPr/>
          </p:nvSpPr>
          <p:spPr>
            <a:xfrm>
              <a:off x="3548282" y="6090538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uN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A1EB9BEB-8151-63CD-8F00-6C7FFB262666}"/>
                </a:ext>
              </a:extLst>
            </p:cNvPr>
            <p:cNvSpPr txBox="1"/>
            <p:nvPr/>
          </p:nvSpPr>
          <p:spPr>
            <a:xfrm>
              <a:off x="593718" y="592085"/>
              <a:ext cx="471613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´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D627B80C-2BB3-6CBA-15A1-46D72FCDE3E4}"/>
                </a:ext>
              </a:extLst>
            </p:cNvPr>
            <p:cNvSpPr txBox="1"/>
            <p:nvPr/>
          </p:nvSpPr>
          <p:spPr>
            <a:xfrm>
              <a:off x="3617499" y="618724"/>
              <a:ext cx="456537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´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648D1C93-CD5A-0A2F-A735-1E43487D1BC8}"/>
                </a:ext>
              </a:extLst>
            </p:cNvPr>
            <p:cNvSpPr txBox="1"/>
            <p:nvPr/>
          </p:nvSpPr>
          <p:spPr>
            <a:xfrm>
              <a:off x="613243" y="3564742"/>
              <a:ext cx="538203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´´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67CB3336-1384-C3E5-E182-48ACF413A7F0}"/>
                </a:ext>
              </a:extLst>
            </p:cNvPr>
            <p:cNvSpPr txBox="1"/>
            <p:nvPr/>
          </p:nvSpPr>
          <p:spPr>
            <a:xfrm>
              <a:off x="3546863" y="3545963"/>
              <a:ext cx="553273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´´</a:t>
              </a:r>
            </a:p>
          </p:txBody>
        </p:sp>
        <p:pic>
          <p:nvPicPr>
            <p:cNvPr id="41" name="Imagen 40" descr="Una estrella en la noche&#10;&#10;Descripción generada automáticamente con confianza media">
              <a:extLst>
                <a:ext uri="{FF2B5EF4-FFF2-40B4-BE49-F238E27FC236}">
                  <a16:creationId xmlns:a16="http://schemas.microsoft.com/office/drawing/2014/main" id="{C90FD3E4-4850-1F47-5849-60364615F1A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4193" y="6491696"/>
              <a:ext cx="2880000" cy="2880000"/>
            </a:xfrm>
            <a:prstGeom prst="rect">
              <a:avLst/>
            </a:prstGeom>
          </p:spPr>
        </p:pic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738D7E52-B912-28C8-780B-EFC3255084E0}"/>
                </a:ext>
              </a:extLst>
            </p:cNvPr>
            <p:cNvSpPr txBox="1"/>
            <p:nvPr/>
          </p:nvSpPr>
          <p:spPr>
            <a:xfrm>
              <a:off x="581810" y="9027364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x2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44" name="CuadroTexto 43">
              <a:extLst>
                <a:ext uri="{FF2B5EF4-FFF2-40B4-BE49-F238E27FC236}">
                  <a16:creationId xmlns:a16="http://schemas.microsoft.com/office/drawing/2014/main" id="{A3A56923-E4B1-C7CE-31A9-9ADB4EFCB182}"/>
                </a:ext>
              </a:extLst>
            </p:cNvPr>
            <p:cNvSpPr txBox="1"/>
            <p:nvPr/>
          </p:nvSpPr>
          <p:spPr>
            <a:xfrm>
              <a:off x="3551839" y="9034023"/>
              <a:ext cx="1762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x2</a:t>
              </a:r>
              <a:r>
                <a:rPr lang="es-ES" sz="16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</a:t>
              </a:r>
              <a:r>
                <a:rPr lang="es-ES" sz="16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01E7BE88-FEC3-D353-CEDF-58E12513573B}"/>
                </a:ext>
              </a:extLst>
            </p:cNvPr>
            <p:cNvSpPr txBox="1"/>
            <p:nvPr/>
          </p:nvSpPr>
          <p:spPr>
            <a:xfrm>
              <a:off x="3550615" y="6507434"/>
              <a:ext cx="665970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´´´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2BB6BB56-847C-291D-1F05-D2AC8532FD33}"/>
                </a:ext>
              </a:extLst>
            </p:cNvPr>
            <p:cNvSpPr txBox="1"/>
            <p:nvPr/>
          </p:nvSpPr>
          <p:spPr>
            <a:xfrm>
              <a:off x="613243" y="6540618"/>
              <a:ext cx="601204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´´´</a:t>
              </a:r>
            </a:p>
          </p:txBody>
        </p:sp>
        <p:pic>
          <p:nvPicPr>
            <p:cNvPr id="8" name="Imagen 7" descr="Gráfico, Gráfico de barras&#10;&#10;Descripción generada automáticamente">
              <a:extLst>
                <a:ext uri="{FF2B5EF4-FFF2-40B4-BE49-F238E27FC236}">
                  <a16:creationId xmlns:a16="http://schemas.microsoft.com/office/drawing/2014/main" id="{860FFE88-7613-579A-CC24-60A699DEE8F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0293" y="9672000"/>
              <a:ext cx="3844334" cy="2520000"/>
            </a:xfrm>
            <a:prstGeom prst="rect">
              <a:avLst/>
            </a:prstGeom>
          </p:spPr>
        </p:pic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020124B9-73FB-D525-2DFB-DD402F9080A4}"/>
                </a:ext>
              </a:extLst>
            </p:cNvPr>
            <p:cNvSpPr txBox="1"/>
            <p:nvPr/>
          </p:nvSpPr>
          <p:spPr>
            <a:xfrm>
              <a:off x="1619465" y="9478568"/>
              <a:ext cx="341655" cy="3694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801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69249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7C9469DF-2C0C-03C5-0409-68EDFA8A1866}"/>
              </a:ext>
            </a:extLst>
          </p:cNvPr>
          <p:cNvSpPr txBox="1"/>
          <p:nvPr/>
        </p:nvSpPr>
        <p:spPr>
          <a:xfrm>
            <a:off x="0" y="1018232"/>
            <a:ext cx="6858000" cy="37691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Characterization of </a:t>
            </a:r>
            <a:r>
              <a:rPr lang="en-US" sz="16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 line: analysis of neuronal markers.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analysis of neuronal markers was performed by immunofluorescence in a primary cell line of human mucosa olfactory ensheathing glia (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; a neuronal primary culture from rat embryonic cortex (E18) was used as a positive control.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neural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uN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(red) was absent from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hile neuronal culture stained positively for this marker (A′′, B′′). However, Tuj1 (green) not only stained embryonic neurons but was also detected in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′, B′).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opulation was not contaminated with neural precursors as SOX2 positive staining (red) was not detected in the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mOEG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ulture, while neural progenitor cells from rat embryonic cortex expressed this neural precursor marker (A′′′, B′′′). Nuclei were stained with DAPI (blue). The histogram (C) represent the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an±SD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the quantifications of triplicates. The statistical test applied was the Student's t-test (n=3, 25 fields were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sed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er experiment). Scale bar: 50 </a:t>
            </a:r>
            <a:r>
              <a:rPr lang="en-US" sz="16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µm.</a:t>
            </a:r>
            <a:endParaRPr lang="es-E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78575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09</TotalTime>
  <Words>226</Words>
  <Application>Microsoft Office PowerPoint</Application>
  <PresentationFormat>Panorámica</PresentationFormat>
  <Paragraphs>16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avier Sierra Isturiz</dc:creator>
  <cp:lastModifiedBy>Javier Sierra Isturiz</cp:lastModifiedBy>
  <cp:revision>19</cp:revision>
  <dcterms:created xsi:type="dcterms:W3CDTF">2023-07-24T11:07:51Z</dcterms:created>
  <dcterms:modified xsi:type="dcterms:W3CDTF">2024-06-10T16:58:16Z</dcterms:modified>
</cp:coreProperties>
</file>